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JP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066"/>
    <p:restoredTop sz="95859"/>
  </p:normalViewPr>
  <p:slideViewPr>
    <p:cSldViewPr snapToGrid="0">
      <p:cViewPr varScale="1">
        <p:scale>
          <a:sx n="78" d="100"/>
          <a:sy n="78" d="100"/>
        </p:scale>
        <p:origin x="200" y="7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4DA542-31A1-DEC4-6363-0C72BE7BBB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9B90150-E152-9168-09EF-299997B777D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72052A-F519-8BD5-02C5-42B8FDF451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ACE90-A6AF-0446-9612-A9BBFC912626}" type="datetimeFigureOut">
              <a:rPr lang="en-JP" smtClean="0"/>
              <a:t>2023/01/23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42F3CE-EBA6-0F9D-16DB-C97024A481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4EC755-3424-9B47-4FEE-E814DF28BE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9D23-BFF1-634B-ACA7-BC012388BC3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435605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47CAA5-D9B8-EA50-63E8-2B4F0B9A7F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0B6E5D-3812-A377-F412-45360C59B7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55D176-7FA7-C036-6DAE-B5FBA8657F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ACE90-A6AF-0446-9612-A9BBFC912626}" type="datetimeFigureOut">
              <a:rPr lang="en-JP" smtClean="0"/>
              <a:t>2023/01/23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48D804-2955-E2E7-8C25-3DDB4216E3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0CFFEF-94CE-35D0-116A-0C0F18DDC9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9D23-BFF1-634B-ACA7-BC012388BC3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95818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CEA008E-283F-A5D0-05BF-4353270776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C5E379-6079-EF0B-C389-A7E765B5E8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0EFF09-5F0D-D27B-C10E-21CC2C8FCC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ACE90-A6AF-0446-9612-A9BBFC912626}" type="datetimeFigureOut">
              <a:rPr lang="en-JP" smtClean="0"/>
              <a:t>2023/01/23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B08B52-8E43-1F90-1B05-DCEF42578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2CD51E-E735-5011-AFE3-09E36F6B47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9D23-BFF1-634B-ACA7-BC012388BC3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1438893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4418E7-5417-A658-065E-D96F921ADB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BAA510-25AA-C67E-095A-0510D59510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2692CC-1371-14D0-36CB-B010C12D9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ACE90-A6AF-0446-9612-A9BBFC912626}" type="datetimeFigureOut">
              <a:rPr lang="en-JP" smtClean="0"/>
              <a:t>2023/01/23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1215AA-35CE-3E33-0FA8-A0FAF70E6A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C975C2-0007-7A27-101F-14CF691CC0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9D23-BFF1-634B-ACA7-BC012388BC3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2222375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1F0664-1CEE-B7B2-C1F8-FA793A0917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D95557-D094-5890-351D-02C9DE4426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ED6C02-0ED3-E9F5-1C3C-F2DFFA1DE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ACE90-A6AF-0446-9612-A9BBFC912626}" type="datetimeFigureOut">
              <a:rPr lang="en-JP" smtClean="0"/>
              <a:t>2023/01/23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967309-C411-6FBD-E9E3-DCF3A6709F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5E0EC3-7192-8B33-A6B7-11BAAC2184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9D23-BFF1-634B-ACA7-BC012388BC3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8906735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1F120C-088A-801A-9157-0A74AB3DCB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5C1C42-F245-F7DB-3536-71BC483D0C4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D86AC5-8CD6-460C-5820-6359DA4534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563701-344D-5423-3C0D-71338835B4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ACE90-A6AF-0446-9612-A9BBFC912626}" type="datetimeFigureOut">
              <a:rPr lang="en-JP" smtClean="0"/>
              <a:t>2023/01/23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BF08A4-A0BA-F667-CF0A-0AA608DECC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316324-0E59-9B72-FBA1-32410767D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9D23-BFF1-634B-ACA7-BC012388BC3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526975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0E44CF-2BD6-8A26-A9EF-DADBF3FF1C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1597AE-89EA-DB17-78C0-0E5656A4FF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3563B7-242E-F0B7-5995-83001E0DD1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C68F6D3-B31F-0955-C64C-6C43802453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3511350-DE62-F7FD-2278-ED01A4DBD9F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178CBA3-9FDF-DE4C-2D3F-3E55592C68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ACE90-A6AF-0446-9612-A9BBFC912626}" type="datetimeFigureOut">
              <a:rPr lang="en-JP" smtClean="0"/>
              <a:t>2023/01/23</a:t>
            </a:fld>
            <a:endParaRPr lang="en-JP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A5C89C7-F102-6A70-80A7-825687E63F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9C5A623-A764-4655-948A-B5EF5FBA13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9D23-BFF1-634B-ACA7-BC012388BC3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759310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5B9799-8D10-D2C0-70A8-7230A5146F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36981BC-8003-BC7F-60B3-85BB059A8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ACE90-A6AF-0446-9612-A9BBFC912626}" type="datetimeFigureOut">
              <a:rPr lang="en-JP" smtClean="0"/>
              <a:t>2023/01/23</a:t>
            </a:fld>
            <a:endParaRPr lang="en-JP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3D97E27-4F19-94B4-73B9-2991763333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80034B4-C1AF-DFB8-F458-B2479F1E94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9D23-BFF1-634B-ACA7-BC012388BC3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8213270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2A96D65-09DE-65E2-60A7-216C513B43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ACE90-A6AF-0446-9612-A9BBFC912626}" type="datetimeFigureOut">
              <a:rPr lang="en-JP" smtClean="0"/>
              <a:t>2023/01/23</a:t>
            </a:fld>
            <a:endParaRPr lang="en-JP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350B15E-E061-E219-F314-7E4FE0A227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5C9CBB1-31B0-D951-95D6-4689F70AC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9D23-BFF1-634B-ACA7-BC012388BC3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748902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71FCFB-2CEC-5EDC-A44B-4DB424463A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D020F3-3827-3565-8D9C-F64764B1D94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E73DE2-844F-557E-E572-A4D802D9A6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9DAC0E-1041-FE76-328E-F08A586B08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ACE90-A6AF-0446-9612-A9BBFC912626}" type="datetimeFigureOut">
              <a:rPr lang="en-JP" smtClean="0"/>
              <a:t>2023/01/23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2DB795-1461-73E4-CB6E-FBCA676370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26C22D-BFC4-624D-B54E-5D72960C09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9D23-BFF1-634B-ACA7-BC012388BC3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887185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E589A0-948D-1DA2-307F-7D1FA1E460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81AF8F-4027-D6D3-1DC7-2EC5EA6439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JP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8D20E3-5207-29FB-5624-C22D48D4D0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D164E6-D4CF-0C29-08B8-CACA02ABB3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ACE90-A6AF-0446-9612-A9BBFC912626}" type="datetimeFigureOut">
              <a:rPr lang="en-JP" smtClean="0"/>
              <a:t>2023/01/23</a:t>
            </a:fld>
            <a:endParaRPr lang="en-JP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466C27-AB99-299B-FAF7-84FB1318DE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3AF964-BE03-067B-1094-0403248928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049D23-BFF1-634B-ACA7-BC012388BC3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860024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797F0B3-6A1E-F14E-8B58-9138E245E6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JP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E546BB-3286-52A6-2494-8B6BEDD326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19A67B-473C-689E-E71A-3D62F211FB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2ACE90-A6AF-0446-9612-A9BBFC912626}" type="datetimeFigureOut">
              <a:rPr lang="en-JP" smtClean="0"/>
              <a:t>2023/01/23</a:t>
            </a:fld>
            <a:endParaRPr lang="en-JP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1777A1-0537-F13D-CDA8-F6DF553FD4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5A9C15-BC90-9509-71BB-DB5D3909A90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049D23-BFF1-634B-ACA7-BC012388BC31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919338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JP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D94BA06-73D4-19AF-E5CF-3C3657F72646}"/>
              </a:ext>
            </a:extLst>
          </p:cNvPr>
          <p:cNvSpPr txBox="1"/>
          <p:nvPr/>
        </p:nvSpPr>
        <p:spPr>
          <a:xfrm>
            <a:off x="2814605" y="566678"/>
            <a:ext cx="6562790" cy="57246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JP" b="1" u="sng" dirty="0">
                <a:latin typeface="Arial" panose="020B0604020202020204" pitchFamily="34" charset="0"/>
                <a:cs typeface="Arial" panose="020B0604020202020204" pitchFamily="34" charset="0"/>
              </a:rPr>
              <a:t>Randomised Controlled Studies at muticenter</a:t>
            </a:r>
          </a:p>
          <a:p>
            <a:pPr algn="ctr"/>
            <a:endParaRPr lang="en-JP" sz="1000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ctr">
              <a:buFont typeface="+mj-lt"/>
              <a:buAutoNum type="arabicPeriod"/>
            </a:pPr>
            <a:r>
              <a:rPr lang="en-JP" dirty="0">
                <a:latin typeface="Arial" panose="020B0604020202020204" pitchFamily="34" charset="0"/>
                <a:cs typeface="Arial" panose="020B0604020202020204" pitchFamily="34" charset="0"/>
              </a:rPr>
              <a:t>EUPHAS, 2009, </a:t>
            </a:r>
            <a:r>
              <a:rPr lang="en-JP" i="1" dirty="0">
                <a:latin typeface="Arial" panose="020B0604020202020204" pitchFamily="34" charset="0"/>
                <a:cs typeface="Arial" panose="020B0604020202020204" pitchFamily="34" charset="0"/>
              </a:rPr>
              <a:t>JAMA</a:t>
            </a:r>
          </a:p>
          <a:p>
            <a:pPr marL="342900" indent="-342900" algn="ctr">
              <a:buFont typeface="+mj-lt"/>
              <a:buAutoNum type="arabicPeriod"/>
            </a:pPr>
            <a:endParaRPr lang="en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ctr">
              <a:buFont typeface="+mj-lt"/>
              <a:buAutoNum type="arabicPeriod"/>
            </a:pPr>
            <a:r>
              <a:rPr lang="en-JP" dirty="0">
                <a:latin typeface="Arial" panose="020B0604020202020204" pitchFamily="34" charset="0"/>
                <a:cs typeface="Arial" panose="020B0604020202020204" pitchFamily="34" charset="0"/>
              </a:rPr>
              <a:t>ABDO-MIX, 2015, </a:t>
            </a:r>
            <a:r>
              <a:rPr lang="en-JP" i="1" dirty="0">
                <a:latin typeface="Arial" panose="020B0604020202020204" pitchFamily="34" charset="0"/>
                <a:cs typeface="Arial" panose="020B0604020202020204" pitchFamily="34" charset="0"/>
              </a:rPr>
              <a:t>Intensiv. Care Med</a:t>
            </a:r>
          </a:p>
          <a:p>
            <a:pPr marL="342900" indent="-342900" algn="ctr">
              <a:buFont typeface="+mj-lt"/>
              <a:buAutoNum type="arabicPeriod"/>
            </a:pPr>
            <a:endParaRPr lang="en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ctr">
              <a:buFont typeface="+mj-lt"/>
              <a:buAutoNum type="arabicPeriod"/>
            </a:pPr>
            <a:r>
              <a:rPr lang="en-JP" dirty="0">
                <a:latin typeface="Arial" panose="020B0604020202020204" pitchFamily="34" charset="0"/>
                <a:cs typeface="Arial" panose="020B0604020202020204" pitchFamily="34" charset="0"/>
              </a:rPr>
              <a:t>EUPHRATES, 2018, </a:t>
            </a:r>
            <a:r>
              <a:rPr lang="en-JP" i="1" dirty="0">
                <a:latin typeface="Arial" panose="020B0604020202020204" pitchFamily="34" charset="0"/>
                <a:cs typeface="Arial" panose="020B0604020202020204" pitchFamily="34" charset="0"/>
              </a:rPr>
              <a:t>JAMA</a:t>
            </a:r>
          </a:p>
          <a:p>
            <a:pPr marL="342900" indent="-342900" algn="ctr">
              <a:buFont typeface="+mj-lt"/>
              <a:buAutoNum type="arabicPeriod"/>
            </a:pPr>
            <a:endParaRPr lang="en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ctr">
              <a:buFont typeface="+mj-lt"/>
              <a:buAutoNum type="arabicPeriod"/>
            </a:pPr>
            <a:r>
              <a:rPr lang="en-JP" dirty="0">
                <a:latin typeface="Arial" panose="020B0604020202020204" pitchFamily="34" charset="0"/>
                <a:cs typeface="Arial" panose="020B0604020202020204" pitchFamily="34" charset="0"/>
              </a:rPr>
              <a:t>Klein’s, 2018, </a:t>
            </a:r>
            <a:r>
              <a:rPr lang="en-JP" i="1" dirty="0">
                <a:latin typeface="Arial" panose="020B0604020202020204" pitchFamily="34" charset="0"/>
                <a:cs typeface="Arial" panose="020B0604020202020204" pitchFamily="34" charset="0"/>
              </a:rPr>
              <a:t>Intensiv. Care Med</a:t>
            </a:r>
          </a:p>
          <a:p>
            <a:pPr marL="342900" indent="-342900" algn="ctr">
              <a:buFont typeface="+mj-lt"/>
              <a:buAutoNum type="arabicPeriod"/>
            </a:pPr>
            <a:endParaRPr lang="en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ctr">
              <a:buFont typeface="+mj-lt"/>
              <a:buAutoNum type="arabicPeriod"/>
            </a:pPr>
            <a:r>
              <a:rPr lang="en-JP" dirty="0">
                <a:latin typeface="Arial" panose="020B0604020202020204" pitchFamily="34" charset="0"/>
                <a:cs typeface="Arial" panose="020B0604020202020204" pitchFamily="34" charset="0"/>
              </a:rPr>
              <a:t>Romaschin’s, 2017, </a:t>
            </a:r>
            <a:r>
              <a:rPr lang="en-JP" i="1" dirty="0">
                <a:latin typeface="Arial" panose="020B0604020202020204" pitchFamily="34" charset="0"/>
                <a:cs typeface="Arial" panose="020B0604020202020204" pitchFamily="34" charset="0"/>
              </a:rPr>
              <a:t>Blood Purif</a:t>
            </a:r>
          </a:p>
          <a:p>
            <a:pPr algn="ctr"/>
            <a:endParaRPr lang="en-JP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JP" b="1" u="sng" dirty="0">
                <a:latin typeface="Arial" panose="020B0604020202020204" pitchFamily="34" charset="0"/>
                <a:cs typeface="Arial" panose="020B0604020202020204" pitchFamily="34" charset="0"/>
              </a:rPr>
              <a:t>Systematic Reviews with meta-analysis</a:t>
            </a:r>
          </a:p>
          <a:p>
            <a:pPr algn="ctr"/>
            <a:endParaRPr lang="en-JP" sz="1000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ctr">
              <a:buFont typeface="+mj-lt"/>
              <a:buAutoNum type="arabicPeriod"/>
            </a:pPr>
            <a:r>
              <a:rPr lang="en-JP" dirty="0">
                <a:latin typeface="Arial" panose="020B0604020202020204" pitchFamily="34" charset="0"/>
                <a:cs typeface="Arial" panose="020B0604020202020204" pitchFamily="34" charset="0"/>
              </a:rPr>
              <a:t>Chang’s, 2017, </a:t>
            </a:r>
            <a:r>
              <a:rPr lang="en-JP" i="1" dirty="0">
                <a:latin typeface="Arial" panose="020B0604020202020204" pitchFamily="34" charset="0"/>
                <a:cs typeface="Arial" panose="020B0604020202020204" pitchFamily="34" charset="0"/>
              </a:rPr>
              <a:t>Crit. Care Med</a:t>
            </a:r>
          </a:p>
          <a:p>
            <a:pPr marL="342900" indent="-342900" algn="ctr">
              <a:buFont typeface="+mj-lt"/>
              <a:buAutoNum type="arabicPeriod"/>
            </a:pPr>
            <a:endParaRPr lang="en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ctr">
              <a:buFont typeface="+mj-lt"/>
              <a:buAutoNum type="arabicPeriod"/>
            </a:pPr>
            <a:r>
              <a:rPr lang="en-JP" dirty="0">
                <a:latin typeface="Arial" panose="020B0604020202020204" pitchFamily="34" charset="0"/>
                <a:cs typeface="Arial" panose="020B0604020202020204" pitchFamily="34" charset="0"/>
              </a:rPr>
              <a:t>Li’s, 2020, </a:t>
            </a:r>
            <a:r>
              <a:rPr lang="en-JP" i="1" dirty="0">
                <a:latin typeface="Arial" panose="020B0604020202020204" pitchFamily="34" charset="0"/>
                <a:cs typeface="Arial" panose="020B0604020202020204" pitchFamily="34" charset="0"/>
              </a:rPr>
              <a:t>J Crit. Care</a:t>
            </a:r>
          </a:p>
          <a:p>
            <a:pPr marL="342900" indent="-342900" algn="ctr">
              <a:buFont typeface="+mj-lt"/>
              <a:buAutoNum type="arabicPeriod"/>
            </a:pPr>
            <a:endParaRPr lang="en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ctr">
              <a:buFont typeface="+mj-lt"/>
              <a:buAutoNum type="arabicPeriod"/>
            </a:pPr>
            <a:r>
              <a:rPr lang="en-JP" dirty="0">
                <a:latin typeface="Arial" panose="020B0604020202020204" pitchFamily="34" charset="0"/>
                <a:cs typeface="Arial" panose="020B0604020202020204" pitchFamily="34" charset="0"/>
              </a:rPr>
              <a:t>Terayama’s, 2017, </a:t>
            </a:r>
            <a:r>
              <a:rPr lang="en-JP" i="1" dirty="0">
                <a:latin typeface="Arial" panose="020B0604020202020204" pitchFamily="34" charset="0"/>
                <a:cs typeface="Arial" panose="020B0604020202020204" pitchFamily="34" charset="0"/>
              </a:rPr>
              <a:t>Surg. Infect</a:t>
            </a:r>
          </a:p>
          <a:p>
            <a:pPr marL="342900" indent="-342900" algn="ctr">
              <a:buFont typeface="+mj-lt"/>
              <a:buAutoNum type="arabicPeriod"/>
            </a:pPr>
            <a:endParaRPr lang="en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ctr">
              <a:buFont typeface="+mj-lt"/>
              <a:buAutoNum type="arabicPeriod"/>
            </a:pPr>
            <a:r>
              <a:rPr lang="en-JP" dirty="0">
                <a:latin typeface="Arial" panose="020B0604020202020204" pitchFamily="34" charset="0"/>
                <a:cs typeface="Arial" panose="020B0604020202020204" pitchFamily="34" charset="0"/>
              </a:rPr>
              <a:t>Fujii’s, 2017, </a:t>
            </a:r>
            <a:r>
              <a:rPr lang="en-JP" i="1" dirty="0">
                <a:latin typeface="Arial" panose="020B0604020202020204" pitchFamily="34" charset="0"/>
                <a:cs typeface="Arial" panose="020B0604020202020204" pitchFamily="34" charset="0"/>
              </a:rPr>
              <a:t>Intesiv. Care Med</a:t>
            </a:r>
          </a:p>
          <a:p>
            <a:pPr algn="ctr"/>
            <a:endParaRPr lang="en-JP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JP" b="1" u="sng" dirty="0">
                <a:latin typeface="Arial" panose="020B0604020202020204" pitchFamily="34" charset="0"/>
                <a:cs typeface="Arial" panose="020B0604020202020204" pitchFamily="34" charset="0"/>
              </a:rPr>
              <a:t>Cohort Studies based on large calinica database</a:t>
            </a:r>
          </a:p>
          <a:p>
            <a:pPr algn="ctr"/>
            <a:endParaRPr lang="en-JP" sz="1000" u="sng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ctr">
              <a:buFont typeface="+mj-lt"/>
              <a:buAutoNum type="arabicPeriod"/>
            </a:pPr>
            <a:r>
              <a:rPr lang="en-JP" dirty="0">
                <a:latin typeface="Arial" panose="020B0604020202020204" pitchFamily="34" charset="0"/>
                <a:cs typeface="Arial" panose="020B0604020202020204" pitchFamily="34" charset="0"/>
              </a:rPr>
              <a:t>Iwagami’s, 2016, </a:t>
            </a:r>
            <a:r>
              <a:rPr lang="en-JP" i="1" dirty="0">
                <a:latin typeface="Arial" panose="020B0604020202020204" pitchFamily="34" charset="0"/>
                <a:cs typeface="Arial" panose="020B0604020202020204" pitchFamily="34" charset="0"/>
              </a:rPr>
              <a:t>Blood Purif</a:t>
            </a:r>
            <a:endParaRPr lang="en-JP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ctr">
              <a:buFont typeface="+mj-lt"/>
              <a:buAutoNum type="arabicPeriod"/>
            </a:pPr>
            <a:endParaRPr lang="en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ctr">
              <a:buFont typeface="+mj-lt"/>
              <a:buAutoNum type="arabicPeriod"/>
            </a:pPr>
            <a:r>
              <a:rPr lang="en-JP" dirty="0">
                <a:latin typeface="Arial" panose="020B0604020202020204" pitchFamily="34" charset="0"/>
                <a:cs typeface="Arial" panose="020B0604020202020204" pitchFamily="34" charset="0"/>
              </a:rPr>
              <a:t>Nakamura’s, 2017, </a:t>
            </a:r>
            <a:r>
              <a:rPr lang="en-JP" i="1" dirty="0">
                <a:latin typeface="Arial" panose="020B0604020202020204" pitchFamily="34" charset="0"/>
                <a:cs typeface="Arial" panose="020B0604020202020204" pitchFamily="34" charset="0"/>
              </a:rPr>
              <a:t>Crit. Care </a:t>
            </a:r>
            <a:endParaRPr lang="en-JP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52949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92</Words>
  <Application>Microsoft Macintosh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eno takuya</dc:creator>
  <cp:lastModifiedBy>ueno takuya</cp:lastModifiedBy>
  <cp:revision>2</cp:revision>
  <dcterms:created xsi:type="dcterms:W3CDTF">2023-01-23T09:17:43Z</dcterms:created>
  <dcterms:modified xsi:type="dcterms:W3CDTF">2023-01-23T14:25:42Z</dcterms:modified>
</cp:coreProperties>
</file>